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howGuides="1">
      <p:cViewPr>
        <p:scale>
          <a:sx n="98" d="100"/>
          <a:sy n="98" d="100"/>
        </p:scale>
        <p:origin x="1747" y="-9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20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137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214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186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3761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4616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106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6401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2001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6236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0944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B6E8F-88AA-479A-A27C-7432D8C45D22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08168-0210-44F6-9A33-4C4EB90BD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917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13E50F89-D5F7-48BB-B43E-1EB915F67A6B}"/>
              </a:ext>
            </a:extLst>
          </p:cNvPr>
          <p:cNvSpPr txBox="1"/>
          <p:nvPr/>
        </p:nvSpPr>
        <p:spPr>
          <a:xfrm>
            <a:off x="260648" y="4016896"/>
            <a:ext cx="6336704" cy="2108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2400"/>
              </a:spcBef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 Transcript level of </a:t>
            </a:r>
            <a:r>
              <a:rPr lang="en-US" altLang="zh-CN" sz="1400" b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asmonate</a:t>
            </a:r>
            <a:r>
              <a:rPr lang="en-US" altLang="zh-CN" sz="14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JA)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responsive genes on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 cinerea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fection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cript level of defensive gene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DF1.2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JA biosynthetic gene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PR3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leaves of WT and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lants after indicated treatments. The 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7</a:t>
            </a:r>
            <a:r>
              <a:rPr lang="en-GB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-9th rosette leaves of 4-week-old plants were detached and inoculated with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otato Dextrose Broth (PDB) or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 cinerea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pores suspension (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or 48 hours, then collected for detecting the transcript level of </a:t>
            </a:r>
            <a:r>
              <a:rPr lang="en-GB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DF.1.2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GB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PR3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CTIN8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as used as the internal control. Data are mean</a:t>
            </a:r>
            <a:r>
              <a:rPr lang="zh-CN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±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D (n=3 samples, each sample contains 3 leaves). Asterisks indicate significant difference (Student’s t-test, *** p &lt; 0.001)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DF78B9A-E8B2-439D-828B-F3F398E340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2670" y="1280592"/>
            <a:ext cx="2232660" cy="21991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712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</TotalTime>
  <Words>126</Words>
  <Application>Microsoft Office PowerPoint</Application>
  <PresentationFormat>A4 纸张(210x297 毫米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wen Li</dc:creator>
  <cp:lastModifiedBy>Yuwen Li</cp:lastModifiedBy>
  <cp:revision>6</cp:revision>
  <dcterms:created xsi:type="dcterms:W3CDTF">2021-07-19T15:04:44Z</dcterms:created>
  <dcterms:modified xsi:type="dcterms:W3CDTF">2021-08-06T04:40:43Z</dcterms:modified>
</cp:coreProperties>
</file>